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40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8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user2\Desktop\CaCo2%20Dif\CS%20activity_1.06.17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user2\Desktop\CaCo2%20Dif\20.04.17_TMRE%20in%20CaCo2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user2\Desktop\CaCo2%20Dif\6.07.17_MitoTrakerRed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7080991000999888"/>
          <c:y val="0.12690994403399641"/>
          <c:w val="0.70214973128359637"/>
          <c:h val="0.725053553077435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 w="9525" cap="flat" cmpd="sng" algn="ctr">
              <a:solidFill>
                <a:schemeClr val="tx1"/>
              </a:solidFill>
              <a:prstDash val="solid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itrateSynthase!$Q$6:$Q$7</c:f>
                <c:numCache>
                  <c:formatCode>General</c:formatCode>
                  <c:ptCount val="2"/>
                  <c:pt idx="0">
                    <c:v>9.4975352412033054</c:v>
                  </c:pt>
                  <c:pt idx="1">
                    <c:v>16.259762939181691</c:v>
                  </c:pt>
                </c:numCache>
              </c:numRef>
            </c:plus>
            <c:minus>
              <c:numRef>
                <c:f>CitrateSynthase!$Q$6:$Q$7</c:f>
                <c:numCache>
                  <c:formatCode>General</c:formatCode>
                  <c:ptCount val="2"/>
                  <c:pt idx="0">
                    <c:v>9.4975352412033054</c:v>
                  </c:pt>
                  <c:pt idx="1">
                    <c:v>16.259762939181691</c:v>
                  </c:pt>
                </c:numCache>
              </c:numRef>
            </c:minus>
          </c:errBars>
          <c:cat>
            <c:strRef>
              <c:f>CitrateSynthase!$O$6:$O$7</c:f>
              <c:strCache>
                <c:ptCount val="2"/>
                <c:pt idx="0">
                  <c:v>Control</c:v>
                </c:pt>
                <c:pt idx="1">
                  <c:v>1mM NaBT</c:v>
                </c:pt>
              </c:strCache>
            </c:strRef>
          </c:cat>
          <c:val>
            <c:numRef>
              <c:f>CitrateSynthase!$P$6:$P$7</c:f>
              <c:numCache>
                <c:formatCode>0.0</c:formatCode>
                <c:ptCount val="2"/>
                <c:pt idx="0" formatCode="0.00">
                  <c:v>98.22453703703701</c:v>
                </c:pt>
                <c:pt idx="1">
                  <c:v>99.74162161435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CD-4A56-9343-A3CFBD6605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531712"/>
        <c:axId val="130533248"/>
      </c:barChart>
      <c:catAx>
        <c:axId val="130531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0"/>
            </a:pPr>
            <a:endParaRPr lang="en-US"/>
          </a:p>
        </c:txPr>
        <c:crossAx val="130533248"/>
        <c:crosses val="autoZero"/>
        <c:auto val="1"/>
        <c:lblAlgn val="ctr"/>
        <c:lblOffset val="100"/>
        <c:noMultiLvlLbl val="0"/>
      </c:catAx>
      <c:valAx>
        <c:axId val="1305332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t-EE" sz="10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CS </a:t>
                </a:r>
                <a:r>
                  <a:rPr lang="et-EE" sz="10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ivity</a:t>
                </a:r>
                <a:r>
                  <a:rPr lang="et-EE" sz="10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 ∙ mg protein</a:t>
                </a:r>
                <a:r>
                  <a:rPr lang="et-EE" sz="1000" b="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lang="en-US" sz="1000" b="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 b="0"/>
            </a:pPr>
            <a:endParaRPr lang="en-US"/>
          </a:p>
        </c:txPr>
        <c:crossAx val="130531712"/>
        <c:crosses val="autoZero"/>
        <c:crossBetween val="between"/>
      </c:valAx>
    </c:plotArea>
    <c:plotVisOnly val="1"/>
    <c:dispBlanksAs val="gap"/>
    <c:showDLblsOverMax val="0"/>
  </c:chart>
  <c:spPr>
    <a:ln>
      <a:noFill/>
    </a:ln>
    <a:effectLst/>
  </c:sp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7154461470093066"/>
          <c:y val="0.12697693087864789"/>
          <c:w val="0.69691401810055364"/>
          <c:h val="0.751840297314639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L$12:$M$12</c:f>
                <c:numCache>
                  <c:formatCode>General</c:formatCode>
                  <c:ptCount val="2"/>
                  <c:pt idx="0">
                    <c:v>5.7413206838187771E-2</c:v>
                  </c:pt>
                  <c:pt idx="1">
                    <c:v>8.3220941291507047E-2</c:v>
                  </c:pt>
                </c:numCache>
              </c:numRef>
            </c:plus>
            <c:minus>
              <c:numRef>
                <c:f>Sheet1!$L$12:$M$12</c:f>
                <c:numCache>
                  <c:formatCode>General</c:formatCode>
                  <c:ptCount val="2"/>
                  <c:pt idx="0">
                    <c:v>5.7413206838187771E-2</c:v>
                  </c:pt>
                  <c:pt idx="1">
                    <c:v>8.3220941291507047E-2</c:v>
                  </c:pt>
                </c:numCache>
              </c:numRef>
            </c:minus>
          </c:errBars>
          <c:cat>
            <c:strRef>
              <c:f>Sheet1!$L$6:$M$6</c:f>
              <c:strCache>
                <c:ptCount val="2"/>
                <c:pt idx="0">
                  <c:v>Control</c:v>
                </c:pt>
                <c:pt idx="1">
                  <c:v>1mM NaBT</c:v>
                </c:pt>
              </c:strCache>
            </c:strRef>
          </c:cat>
          <c:val>
            <c:numRef>
              <c:f>Sheet1!$L$11:$M$11</c:f>
              <c:numCache>
                <c:formatCode>General</c:formatCode>
                <c:ptCount val="2"/>
                <c:pt idx="0">
                  <c:v>0.3481583333333334</c:v>
                </c:pt>
                <c:pt idx="1">
                  <c:v>0.335691666666668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9D-4CAC-BE47-B9EB8EF82F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550400"/>
        <c:axId val="130552192"/>
      </c:barChart>
      <c:catAx>
        <c:axId val="130550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30552192"/>
        <c:crosses val="autoZero"/>
        <c:auto val="1"/>
        <c:lblAlgn val="ctr"/>
        <c:lblOffset val="100"/>
        <c:noMultiLvlLbl val="0"/>
      </c:catAx>
      <c:valAx>
        <c:axId val="130552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sz="10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t-EE" sz="10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uorescence</a:t>
                </a:r>
                <a:r>
                  <a:rPr lang="et-EE" sz="10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 ∙ mg protein</a:t>
                </a:r>
                <a:r>
                  <a:rPr lang="et-EE" sz="1000" b="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lang="en-US" sz="1000" b="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crossAx val="1305504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826924248560179"/>
          <c:y val="0.10901103581083582"/>
          <c:w val="0.71117546079109484"/>
          <c:h val="0.7089988972418718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embraani potentsiaal'!$B$62:$C$62</c:f>
                <c:numCache>
                  <c:formatCode>General</c:formatCode>
                  <c:ptCount val="2"/>
                  <c:pt idx="0">
                    <c:v>0.12005026920100753</c:v>
                  </c:pt>
                  <c:pt idx="1">
                    <c:v>8.3772639634010534E-2</c:v>
                  </c:pt>
                </c:numCache>
              </c:numRef>
            </c:plus>
            <c:minus>
              <c:numRef>
                <c:f>'Membraani potentsiaal'!$B$62:$C$62</c:f>
                <c:numCache>
                  <c:formatCode>General</c:formatCode>
                  <c:ptCount val="2"/>
                  <c:pt idx="0">
                    <c:v>0.12005026920100753</c:v>
                  </c:pt>
                  <c:pt idx="1">
                    <c:v>8.3772639634010534E-2</c:v>
                  </c:pt>
                </c:numCache>
              </c:numRef>
            </c:minus>
          </c:errBars>
          <c:cat>
            <c:strRef>
              <c:f>'Membraani potentsiaal'!$B$60:$C$60</c:f>
              <c:strCache>
                <c:ptCount val="2"/>
                <c:pt idx="0">
                  <c:v>Control</c:v>
                </c:pt>
                <c:pt idx="1">
                  <c:v>1mM NaBT</c:v>
                </c:pt>
              </c:strCache>
            </c:strRef>
          </c:cat>
          <c:val>
            <c:numRef>
              <c:f>'Membraani potentsiaal'!$B$61:$C$61</c:f>
              <c:numCache>
                <c:formatCode>General</c:formatCode>
                <c:ptCount val="2"/>
                <c:pt idx="0">
                  <c:v>0.59335988431306896</c:v>
                </c:pt>
                <c:pt idx="1">
                  <c:v>0.719588289590956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C9-4C4C-B5FD-2C703B88C2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598016"/>
        <c:axId val="130599552"/>
      </c:barChart>
      <c:catAx>
        <c:axId val="1305980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t-EE"/>
            </a:pPr>
            <a:endParaRPr lang="en-US"/>
          </a:p>
        </c:txPr>
        <c:crossAx val="130599552"/>
        <c:crosses val="autoZero"/>
        <c:auto val="1"/>
        <c:lblAlgn val="ctr"/>
        <c:lblOffset val="100"/>
        <c:noMultiLvlLbl val="0"/>
      </c:catAx>
      <c:valAx>
        <c:axId val="1305995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sz="10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t-EE" sz="1000" b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uorescence</a:t>
                </a:r>
                <a:r>
                  <a:rPr lang="et-EE" sz="10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∙ </a:t>
                </a:r>
                <a:r>
                  <a:rPr lang="et-EE" sz="10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mg protein</a:t>
                </a:r>
                <a:r>
                  <a:rPr lang="et-EE" sz="1000" b="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endParaRPr lang="en-US" sz="1000" b="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t-EE"/>
            </a:pPr>
            <a:endParaRPr lang="en-US"/>
          </a:p>
        </c:txPr>
        <c:crossAx val="1305980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2653</cdr:x>
      <cdr:y>0.2425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495285" cy="4667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GB" sz="1400" b="1" dirty="0">
              <a:latin typeface="Arial" panose="020B0604020202020204" pitchFamily="34" charset="0"/>
              <a:cs typeface="Arial" panose="020B0604020202020204" pitchFamily="34" charset="0"/>
            </a:rPr>
            <a:t>A</a:t>
          </a:r>
          <a:endParaRPr lang="en-US" sz="14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2933</cdr:x>
      <cdr:y>0.2094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572805" cy="5746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GB" sz="1400" b="1" dirty="0">
              <a:latin typeface="Arial" panose="020B0604020202020204" pitchFamily="34" charset="0"/>
              <a:cs typeface="Arial" panose="020B0604020202020204" pitchFamily="34" charset="0"/>
            </a:rPr>
            <a:t>B</a:t>
          </a:r>
          <a:endParaRPr lang="en-US" sz="14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2841</cdr:x>
      <cdr:y>0.04269</cdr:y>
    </cdr:from>
    <cdr:to>
      <cdr:x>0.88194</cdr:x>
      <cdr:y>0.4914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BB2422FA-23EA-4543-98EC-83036D048C67}"/>
            </a:ext>
          </a:extLst>
        </cdr:cNvPr>
        <cdr:cNvSpPr txBox="1"/>
      </cdr:nvSpPr>
      <cdr:spPr>
        <a:xfrm xmlns:a="http://schemas.openxmlformats.org/drawingml/2006/main">
          <a:off x="863780" y="8698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100" dirty="0">
              <a:latin typeface="Arial" panose="020B0604020202020204" pitchFamily="34" charset="0"/>
              <a:cs typeface="Arial" panose="020B0604020202020204" pitchFamily="34" charset="0"/>
            </a:rPr>
            <a:t>TMRE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2933</cdr:x>
      <cdr:y>0.2094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465588" cy="6032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GB" sz="1400" b="1" dirty="0">
              <a:latin typeface="Arial" panose="020B0604020202020204" pitchFamily="34" charset="0"/>
              <a:cs typeface="Arial" panose="020B0604020202020204" pitchFamily="34" charset="0"/>
            </a:rPr>
            <a:t>C</a:t>
          </a:r>
          <a:endParaRPr lang="en-US" sz="14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2399</cdr:x>
      <cdr:y>0.03978</cdr:y>
    </cdr:from>
    <cdr:to>
      <cdr:x>0.74728</cdr:x>
      <cdr:y>0.45795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57128CF0-CBFD-49A8-9DF1-55EDAEDA97C7}"/>
            </a:ext>
          </a:extLst>
        </cdr:cNvPr>
        <cdr:cNvSpPr txBox="1"/>
      </cdr:nvSpPr>
      <cdr:spPr>
        <a:xfrm xmlns:a="http://schemas.openxmlformats.org/drawingml/2006/main">
          <a:off x="699895" y="8698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100" dirty="0" err="1">
              <a:latin typeface="Arial" panose="020B0604020202020204" pitchFamily="34" charset="0"/>
              <a:cs typeface="Arial" panose="020B0604020202020204" pitchFamily="34" charset="0"/>
            </a:rPr>
            <a:t>MitoTracker</a:t>
          </a:r>
          <a:r>
            <a:rPr lang="en-GB" sz="1100" dirty="0">
              <a:latin typeface="Arial" panose="020B0604020202020204" pitchFamily="34" charset="0"/>
              <a:cs typeface="Arial" panose="020B0604020202020204" pitchFamily="34" charset="0"/>
            </a:rPr>
            <a:t> Red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178222"/>
            <a:ext cx="5814457" cy="250642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3781306"/>
            <a:ext cx="5130404" cy="1738167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8379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476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383297"/>
            <a:ext cx="1474991" cy="61010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383297"/>
            <a:ext cx="4339466" cy="61010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846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366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1794831"/>
            <a:ext cx="5899964" cy="2994714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4817876"/>
            <a:ext cx="5899964" cy="15748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9170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1916484"/>
            <a:ext cx="2907229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1916484"/>
            <a:ext cx="2907229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548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383299"/>
            <a:ext cx="5899964" cy="1391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1764832"/>
            <a:ext cx="2893868" cy="86491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2629749"/>
            <a:ext cx="2893868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1764832"/>
            <a:ext cx="2908120" cy="86491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2629749"/>
            <a:ext cx="2908120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924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4168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2366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79954"/>
            <a:ext cx="2206252" cy="167984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036570"/>
            <a:ext cx="3463022" cy="5116178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159794"/>
            <a:ext cx="2206252" cy="400128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2924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79954"/>
            <a:ext cx="2206252" cy="167984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036570"/>
            <a:ext cx="3463022" cy="5116178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159794"/>
            <a:ext cx="2206252" cy="400128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4115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383299"/>
            <a:ext cx="5899964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1916484"/>
            <a:ext cx="5899964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6672698"/>
            <a:ext cx="1539121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F1B7A-93F1-4CED-B2EC-055A0BC93B4A}" type="datetimeFigureOut">
              <a:rPr lang="en-GB" smtClean="0"/>
              <a:t>15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6672698"/>
            <a:ext cx="2308682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6672698"/>
            <a:ext cx="1539121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E93EA-668A-4F4E-91A7-39EC495FE3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7206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7E55272-E121-4DC7-A10D-689705F8F22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25776114"/>
              </p:ext>
            </p:extLst>
          </p:nvPr>
        </p:nvGraphicFramePr>
        <p:xfrm>
          <a:off x="453397" y="1860055"/>
          <a:ext cx="1800200" cy="21088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893E66D-8AB0-4E62-A5C4-3D3E9EEF30E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445416637"/>
              </p:ext>
            </p:extLst>
          </p:nvPr>
        </p:nvGraphicFramePr>
        <p:xfrm>
          <a:off x="2412157" y="1860055"/>
          <a:ext cx="2016224" cy="20374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D74CA80-2C05-4985-B702-AB63462A0E7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28551150"/>
              </p:ext>
            </p:extLst>
          </p:nvPr>
        </p:nvGraphicFramePr>
        <p:xfrm>
          <a:off x="4405359" y="1860055"/>
          <a:ext cx="2160240" cy="2186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BCFCDAEB-979A-4FEA-A2C4-2EE32109AC8A}"/>
              </a:ext>
            </a:extLst>
          </p:cNvPr>
          <p:cNvSpPr txBox="1"/>
          <p:nvPr/>
        </p:nvSpPr>
        <p:spPr>
          <a:xfrm>
            <a:off x="260648" y="128464"/>
            <a:ext cx="6264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b="1" dirty="0"/>
              <a:t>Supplementary </a:t>
            </a:r>
            <a:r>
              <a:rPr lang="en-GB" sz="1400" b="1" dirty="0"/>
              <a:t>Figure 6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ECF8EC2-A769-4B42-8B68-12F938CD1E7E}"/>
              </a:ext>
            </a:extLst>
          </p:cNvPr>
          <p:cNvSpPr txBox="1"/>
          <p:nvPr/>
        </p:nvSpPr>
        <p:spPr>
          <a:xfrm>
            <a:off x="260648" y="5286629"/>
            <a:ext cx="6264696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t-EE" sz="1400" b="1" dirty="0"/>
              <a:t>Supplementary </a:t>
            </a:r>
            <a:r>
              <a:rPr lang="et-EE" sz="1400" b="1" dirty="0" err="1"/>
              <a:t>figure</a:t>
            </a:r>
            <a:r>
              <a:rPr lang="et-EE" sz="1400" b="1" dirty="0"/>
              <a:t> </a:t>
            </a:r>
            <a:r>
              <a:rPr lang="en-GB" sz="1400" b="1" dirty="0"/>
              <a:t>6</a:t>
            </a:r>
            <a:endParaRPr lang="en-US" sz="1400" b="1" dirty="0"/>
          </a:p>
          <a:p>
            <a:endParaRPr lang="en-US" sz="1400" b="1" dirty="0"/>
          </a:p>
          <a:p>
            <a:pPr algn="just"/>
            <a:r>
              <a:rPr lang="en-GB" sz="1200" b="1" dirty="0"/>
              <a:t>Effect of sodium butyrate on the mitochondrial mass and membrane potential. </a:t>
            </a:r>
            <a:r>
              <a:rPr lang="et-EE" sz="1200" dirty="0"/>
              <a:t>(</a:t>
            </a:r>
            <a:r>
              <a:rPr lang="en-GB" sz="1200" dirty="0"/>
              <a:t>A</a:t>
            </a:r>
            <a:r>
              <a:rPr lang="et-EE" sz="1200" dirty="0"/>
              <a:t>):  Specific citrate synthase activity. (</a:t>
            </a:r>
            <a:r>
              <a:rPr lang="en-GB" sz="1200" dirty="0"/>
              <a:t>B</a:t>
            </a:r>
            <a:r>
              <a:rPr lang="et-EE" sz="1200" dirty="0"/>
              <a:t>,</a:t>
            </a:r>
            <a:r>
              <a:rPr lang="en-GB" sz="1200" dirty="0"/>
              <a:t>C</a:t>
            </a:r>
            <a:r>
              <a:rPr lang="et-EE" sz="1200" dirty="0"/>
              <a:t>): Mitochondrial membrane potential was assayed by TMRE and MitoTracker Red staining using fluorescence microplate reader. Data presented as mean ± SEM (n = 5). NaBT – sodium butyrat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749806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84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ksandr Klepinin</dc:creator>
  <cp:lastModifiedBy>Ljudmila Ounpuu</cp:lastModifiedBy>
  <cp:revision>3</cp:revision>
  <dcterms:created xsi:type="dcterms:W3CDTF">2020-03-16T10:28:54Z</dcterms:created>
  <dcterms:modified xsi:type="dcterms:W3CDTF">2020-11-15T19:42:42Z</dcterms:modified>
</cp:coreProperties>
</file>